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E773D-A27B-4556-B154-1A808B992E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1BA29-93AA-4332-AC24-3696B940A8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1784B-993E-4349-B624-F20781DC6B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3C8C1-F735-4066-A5E6-1100D211B6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DB34E-9227-45C2-8066-C9F5218AD9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3E5B06-2861-4229-A694-89DAE428C2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D87B7-3D9E-4D56-958D-6EB4AF62DD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395FF6-6AC5-47CB-9403-9B334C2943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32E51-D8DC-49F3-88FC-FD841CB304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8195B-954A-44C2-801A-03BF27B862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CD9BF-34BA-41CA-9CA9-0B02CF4BE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B20D9-F855-4224-A942-4A9FD178E6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FFD262-F69D-424A-8749-9D450C88470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419040" y="4038480"/>
            <a:ext cx="6210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7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ative diagram of the total number of induced and repressed genes and common regulated genes between C418 and K354 at phase I (2-6 h), phase II (12 h), and phase III (24-48 h) of cold-respons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induced genes by cold; B. repressed genes by cold. Blue, red, and green bars indicate K354-specific (blue bar), common (red bar), and C418-specific (green bar) regulated genes by cold stres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8"/>
          <p:cNvSpPr/>
          <p:nvPr/>
        </p:nvSpPr>
        <p:spPr>
          <a:xfrm>
            <a:off x="1023120" y="914400"/>
            <a:ext cx="109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9"/>
          <p:cNvSpPr/>
          <p:nvPr/>
        </p:nvSpPr>
        <p:spPr>
          <a:xfrm>
            <a:off x="3479760" y="914400"/>
            <a:ext cx="101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2"/>
          <p:cNvSpPr/>
          <p:nvPr/>
        </p:nvSpPr>
        <p:spPr>
          <a:xfrm>
            <a:off x="670680" y="1621080"/>
            <a:ext cx="332640" cy="11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umber of prob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53"/>
          <p:cNvSpPr/>
          <p:nvPr/>
        </p:nvSpPr>
        <p:spPr>
          <a:xfrm>
            <a:off x="1324440" y="3297240"/>
            <a:ext cx="153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ld-responsive st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2"/>
          <p:cNvSpPr/>
          <p:nvPr/>
        </p:nvSpPr>
        <p:spPr>
          <a:xfrm>
            <a:off x="3132720" y="1629000"/>
            <a:ext cx="332640" cy="11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umber of prob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63"/>
          <p:cNvSpPr/>
          <p:nvPr/>
        </p:nvSpPr>
        <p:spPr>
          <a:xfrm>
            <a:off x="3787560" y="3306600"/>
            <a:ext cx="153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ld-responsive st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23"/>
          <p:cNvGrpSpPr/>
          <p:nvPr/>
        </p:nvGrpSpPr>
        <p:grpSpPr>
          <a:xfrm>
            <a:off x="939960" y="1206360"/>
            <a:ext cx="2187360" cy="2192400"/>
            <a:chOff x="939960" y="1206360"/>
            <a:chExt cx="2187360" cy="2192400"/>
          </a:xfrm>
        </p:grpSpPr>
        <p:sp>
          <p:nvSpPr>
            <p:cNvPr id="49" name="AutoShape 21"/>
            <p:cNvSpPr/>
            <p:nvPr/>
          </p:nvSpPr>
          <p:spPr>
            <a:xfrm>
              <a:off x="939960" y="1206360"/>
              <a:ext cx="2187360" cy="2192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6"/>
            <p:cNvSpPr/>
            <p:nvPr/>
          </p:nvSpPr>
          <p:spPr>
            <a:xfrm>
              <a:off x="1166760" y="1314000"/>
              <a:ext cx="79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nduc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23"/>
            <p:cNvSpPr/>
            <p:nvPr/>
          </p:nvSpPr>
          <p:spPr>
            <a:xfrm>
              <a:off x="1166760" y="1319040"/>
              <a:ext cx="1893960" cy="1839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24"/>
            <p:cNvSpPr/>
            <p:nvPr/>
          </p:nvSpPr>
          <p:spPr>
            <a:xfrm>
              <a:off x="1165320" y="1314000"/>
              <a:ext cx="1898640" cy="1847880"/>
            </a:xfrm>
            <a:prstGeom prst="pi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25"/>
            <p:cNvSpPr/>
            <p:nvPr/>
          </p:nvSpPr>
          <p:spPr>
            <a:xfrm>
              <a:off x="1271520" y="2660760"/>
              <a:ext cx="1403280" cy="498240"/>
            </a:xfrm>
            <a:prstGeom prst="pie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26"/>
            <p:cNvSpPr/>
            <p:nvPr/>
          </p:nvSpPr>
          <p:spPr>
            <a:xfrm>
              <a:off x="1413000" y="1439640"/>
              <a:ext cx="1403280" cy="1719360"/>
            </a:xfrm>
            <a:prstGeom prst="pie">
              <a:avLst/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27"/>
            <p:cNvSpPr/>
            <p:nvPr/>
          </p:nvSpPr>
          <p:spPr>
            <a:xfrm>
              <a:off x="1552680" y="2576520"/>
              <a:ext cx="1403280" cy="582480"/>
            </a:xfrm>
            <a:prstGeom prst="pie">
              <a:avLst/>
            </a:prstGeom>
            <a:solidFill>
              <a:srgbClr val="9bbb5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8"/>
            <p:cNvSpPr/>
            <p:nvPr/>
          </p:nvSpPr>
          <p:spPr>
            <a:xfrm>
              <a:off x="1165320" y="1319040"/>
              <a:ext cx="2880" cy="1839960"/>
            </a:xfrm>
            <a:prstGeom prst="rect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29"/>
            <p:cNvSpPr/>
            <p:nvPr/>
          </p:nvSpPr>
          <p:spPr>
            <a:xfrm>
              <a:off x="1147680" y="1314000"/>
              <a:ext cx="18720" cy="1847880"/>
            </a:xfrm>
            <a:prstGeom prst="pie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0"/>
            <p:cNvSpPr/>
            <p:nvPr/>
          </p:nvSpPr>
          <p:spPr>
            <a:xfrm>
              <a:off x="1166760" y="3154320"/>
              <a:ext cx="1893960" cy="7920"/>
            </a:xfrm>
            <a:prstGeom prst="rect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31"/>
            <p:cNvSpPr/>
            <p:nvPr/>
          </p:nvSpPr>
          <p:spPr>
            <a:xfrm>
              <a:off x="1165320" y="3159360"/>
              <a:ext cx="1898640" cy="31680"/>
            </a:xfrm>
            <a:prstGeom prst="pie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2"/>
            <p:cNvSpPr/>
            <p:nvPr/>
          </p:nvSpPr>
          <p:spPr>
            <a:xfrm>
              <a:off x="1080720" y="3097080"/>
              <a:ext cx="3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3"/>
            <p:cNvSpPr/>
            <p:nvPr/>
          </p:nvSpPr>
          <p:spPr>
            <a:xfrm>
              <a:off x="1012680" y="278928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4"/>
            <p:cNvSpPr/>
            <p:nvPr/>
          </p:nvSpPr>
          <p:spPr>
            <a:xfrm>
              <a:off x="1012680" y="248292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5"/>
            <p:cNvSpPr/>
            <p:nvPr/>
          </p:nvSpPr>
          <p:spPr>
            <a:xfrm>
              <a:off x="1012680" y="217620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36"/>
            <p:cNvSpPr/>
            <p:nvPr/>
          </p:nvSpPr>
          <p:spPr>
            <a:xfrm>
              <a:off x="1012680" y="186984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7"/>
            <p:cNvSpPr/>
            <p:nvPr/>
          </p:nvSpPr>
          <p:spPr>
            <a:xfrm>
              <a:off x="979920" y="1561680"/>
              <a:ext cx="15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8"/>
            <p:cNvSpPr/>
            <p:nvPr/>
          </p:nvSpPr>
          <p:spPr>
            <a:xfrm>
              <a:off x="979920" y="1255320"/>
              <a:ext cx="15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9"/>
            <p:cNvSpPr/>
            <p:nvPr/>
          </p:nvSpPr>
          <p:spPr>
            <a:xfrm>
              <a:off x="1312200" y="321804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ase 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40"/>
            <p:cNvSpPr/>
            <p:nvPr/>
          </p:nvSpPr>
          <p:spPr>
            <a:xfrm>
              <a:off x="1930320" y="3218040"/>
              <a:ext cx="264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ase I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41"/>
            <p:cNvSpPr/>
            <p:nvPr/>
          </p:nvSpPr>
          <p:spPr>
            <a:xfrm>
              <a:off x="2563560" y="3218040"/>
              <a:ext cx="29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ase II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AutoShape 43"/>
          <p:cNvSpPr/>
          <p:nvPr/>
        </p:nvSpPr>
        <p:spPr>
          <a:xfrm>
            <a:off x="3421080" y="1211400"/>
            <a:ext cx="2214720" cy="219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Group 47"/>
          <p:cNvGrpSpPr/>
          <p:nvPr/>
        </p:nvGrpSpPr>
        <p:grpSpPr>
          <a:xfrm>
            <a:off x="3460680" y="1262160"/>
            <a:ext cx="2109960" cy="2052360"/>
            <a:chOff x="3460680" y="1262160"/>
            <a:chExt cx="2109960" cy="2052360"/>
          </a:xfrm>
        </p:grpSpPr>
        <p:sp>
          <p:nvSpPr>
            <p:cNvPr id="72" name="Rectangle 45"/>
            <p:cNvSpPr/>
            <p:nvPr/>
          </p:nvSpPr>
          <p:spPr>
            <a:xfrm>
              <a:off x="3616200" y="1323720"/>
              <a:ext cx="1953000" cy="1839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46"/>
            <p:cNvSpPr/>
            <p:nvPr/>
          </p:nvSpPr>
          <p:spPr>
            <a:xfrm>
              <a:off x="3614400" y="1319040"/>
              <a:ext cx="1956240" cy="1847880"/>
            </a:xfrm>
            <a:prstGeom prst="pi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47"/>
            <p:cNvSpPr/>
            <p:nvPr/>
          </p:nvSpPr>
          <p:spPr>
            <a:xfrm>
              <a:off x="3725640" y="2732040"/>
              <a:ext cx="1444680" cy="431640"/>
            </a:xfrm>
            <a:prstGeom prst="pie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48"/>
            <p:cNvSpPr/>
            <p:nvPr/>
          </p:nvSpPr>
          <p:spPr>
            <a:xfrm>
              <a:off x="3870000" y="1859040"/>
              <a:ext cx="1446480" cy="1305000"/>
            </a:xfrm>
            <a:prstGeom prst="pie">
              <a:avLst/>
            </a:prstGeom>
            <a:solidFill>
              <a:srgbClr val="c0504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49"/>
            <p:cNvSpPr/>
            <p:nvPr/>
          </p:nvSpPr>
          <p:spPr>
            <a:xfrm>
              <a:off x="4014720" y="1606320"/>
              <a:ext cx="1444680" cy="1557360"/>
            </a:xfrm>
            <a:prstGeom prst="pie">
              <a:avLst/>
            </a:prstGeom>
            <a:solidFill>
              <a:srgbClr val="9bbb5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50"/>
            <p:cNvSpPr/>
            <p:nvPr/>
          </p:nvSpPr>
          <p:spPr>
            <a:xfrm>
              <a:off x="3614400" y="1323720"/>
              <a:ext cx="4680" cy="1839960"/>
            </a:xfrm>
            <a:prstGeom prst="rect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51"/>
            <p:cNvSpPr/>
            <p:nvPr/>
          </p:nvSpPr>
          <p:spPr>
            <a:xfrm>
              <a:off x="3598560" y="1319040"/>
              <a:ext cx="17280" cy="1847880"/>
            </a:xfrm>
            <a:prstGeom prst="pie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52"/>
            <p:cNvSpPr/>
            <p:nvPr/>
          </p:nvSpPr>
          <p:spPr>
            <a:xfrm>
              <a:off x="3616200" y="3159360"/>
              <a:ext cx="1953000" cy="7920"/>
            </a:xfrm>
            <a:prstGeom prst="rect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53"/>
            <p:cNvSpPr/>
            <p:nvPr/>
          </p:nvSpPr>
          <p:spPr>
            <a:xfrm>
              <a:off x="3614400" y="3164040"/>
              <a:ext cx="1956240" cy="31680"/>
            </a:xfrm>
            <a:prstGeom prst="pie">
              <a:avLst/>
            </a:prstGeom>
            <a:solidFill>
              <a:srgbClr val="868686"/>
            </a:solidFill>
            <a:ln w="0">
              <a:solidFill>
                <a:srgbClr val="868686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760" bIns="-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54"/>
            <p:cNvSpPr/>
            <p:nvPr/>
          </p:nvSpPr>
          <p:spPr>
            <a:xfrm>
              <a:off x="3528360" y="3102120"/>
              <a:ext cx="3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55"/>
            <p:cNvSpPr/>
            <p:nvPr/>
          </p:nvSpPr>
          <p:spPr>
            <a:xfrm>
              <a:off x="3495600" y="2840040"/>
              <a:ext cx="77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6"/>
            <p:cNvSpPr/>
            <p:nvPr/>
          </p:nvSpPr>
          <p:spPr>
            <a:xfrm>
              <a:off x="3460680" y="257652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7"/>
            <p:cNvSpPr/>
            <p:nvPr/>
          </p:nvSpPr>
          <p:spPr>
            <a:xfrm>
              <a:off x="3460680" y="231300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8"/>
            <p:cNvSpPr/>
            <p:nvPr/>
          </p:nvSpPr>
          <p:spPr>
            <a:xfrm>
              <a:off x="3460680" y="204948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9"/>
            <p:cNvSpPr/>
            <p:nvPr/>
          </p:nvSpPr>
          <p:spPr>
            <a:xfrm>
              <a:off x="3460680" y="178596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60"/>
            <p:cNvSpPr/>
            <p:nvPr/>
          </p:nvSpPr>
          <p:spPr>
            <a:xfrm>
              <a:off x="3460680" y="152388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61"/>
            <p:cNvSpPr/>
            <p:nvPr/>
          </p:nvSpPr>
          <p:spPr>
            <a:xfrm>
              <a:off x="3460680" y="1262160"/>
              <a:ext cx="115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62"/>
            <p:cNvSpPr/>
            <p:nvPr/>
          </p:nvSpPr>
          <p:spPr>
            <a:xfrm>
              <a:off x="3758040" y="322272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ase 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63"/>
            <p:cNvSpPr/>
            <p:nvPr/>
          </p:nvSpPr>
          <p:spPr>
            <a:xfrm>
              <a:off x="4405320" y="3222720"/>
              <a:ext cx="264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ase I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64"/>
            <p:cNvSpPr/>
            <p:nvPr/>
          </p:nvSpPr>
          <p:spPr>
            <a:xfrm>
              <a:off x="5063040" y="3222720"/>
              <a:ext cx="29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ase II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TextBox 16"/>
          <p:cNvSpPr/>
          <p:nvPr/>
        </p:nvSpPr>
        <p:spPr>
          <a:xfrm>
            <a:off x="3611520" y="13240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s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6"/>
          <p:cNvSpPr/>
          <p:nvPr/>
        </p:nvSpPr>
        <p:spPr>
          <a:xfrm>
            <a:off x="1173240" y="1324080"/>
            <a:ext cx="73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duc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38"/>
          <p:cNvSpPr/>
          <p:nvPr/>
        </p:nvSpPr>
        <p:spPr>
          <a:xfrm>
            <a:off x="1295280" y="1643040"/>
            <a:ext cx="52560" cy="921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39"/>
          <p:cNvSpPr/>
          <p:nvPr/>
        </p:nvSpPr>
        <p:spPr>
          <a:xfrm>
            <a:off x="1366200" y="1619280"/>
            <a:ext cx="700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K354-specifi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40"/>
          <p:cNvSpPr/>
          <p:nvPr/>
        </p:nvSpPr>
        <p:spPr>
          <a:xfrm>
            <a:off x="1295280" y="1801800"/>
            <a:ext cx="52560" cy="92160"/>
          </a:xfrm>
          <a:prstGeom prst="rect">
            <a:avLst/>
          </a:prstGeom>
          <a:solidFill>
            <a:srgbClr val="c050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41"/>
          <p:cNvSpPr/>
          <p:nvPr/>
        </p:nvSpPr>
        <p:spPr>
          <a:xfrm>
            <a:off x="1357920" y="1778040"/>
            <a:ext cx="492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mm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42"/>
          <p:cNvSpPr/>
          <p:nvPr/>
        </p:nvSpPr>
        <p:spPr>
          <a:xfrm>
            <a:off x="1295280" y="1957320"/>
            <a:ext cx="52560" cy="93600"/>
          </a:xfrm>
          <a:prstGeom prst="rect">
            <a:avLst/>
          </a:prstGeom>
          <a:solidFill>
            <a:srgbClr val="9bbb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43"/>
          <p:cNvSpPr/>
          <p:nvPr/>
        </p:nvSpPr>
        <p:spPr>
          <a:xfrm>
            <a:off x="1368720" y="1935000"/>
            <a:ext cx="701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418-specifi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Fan Zhang</dc:creator>
  <dc:description/>
  <dc:language>en-US</dc:language>
  <cp:lastModifiedBy>Fan</cp:lastModifiedBy>
  <dcterms:modified xsi:type="dcterms:W3CDTF">2012-08-01T08:45:24Z</dcterms:modified>
  <cp:revision>16</cp:revision>
  <dc:subject/>
  <dc:title>PowerPoint Presentation</dc:title>
</cp:coreProperties>
</file>